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907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B255D6-B858-49B2-AA0E-130D0B58F40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6E2B10-D1E8-4738-811A-9CA748873EF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8B558B-4F3A-42D0-AFDF-5294D35018C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0964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52428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9500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0964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52428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EAE769-6F3A-4FBF-B0D4-466763421FC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5A6581-BF4D-4129-874F-1EFD3ECDD3B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03187C-821C-4154-9E5F-A3B582A8177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92194D-6ACC-4753-9F06-3336FD8BF2B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87D6C1-D7FB-4083-8860-42B6814AB38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95000" y="274320"/>
            <a:ext cx="8915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7A2FC2-87AA-4977-B9A1-A8D85B20862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A4EF4E-A349-48FB-9D13-A24EDCC5EE5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002784-9208-4592-8A10-FCFF2AD473D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573CE4-0F1F-465E-8142-589F1C4A1A1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95360" y="6244920"/>
            <a:ext cx="231120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384360" y="6244920"/>
            <a:ext cx="313668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098840" y="6244920"/>
            <a:ext cx="231156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DB33644-9D95-42A3-8558-BACB8951BEAB}" type="slidenum">
              <a:rPr b="0" lang="fr-F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371520" y="320760"/>
            <a:ext cx="1360440" cy="560160"/>
            <a:chOff x="371520" y="320760"/>
            <a:chExt cx="1360440" cy="560160"/>
          </a:xfrm>
        </p:grpSpPr>
        <p:sp>
          <p:nvSpPr>
            <p:cNvPr id="42" name=""/>
            <p:cNvSpPr/>
            <p:nvPr/>
          </p:nvSpPr>
          <p:spPr>
            <a:xfrm>
              <a:off x="371520" y="320760"/>
              <a:ext cx="1360440" cy="560160"/>
            </a:xfrm>
            <a:prstGeom prst="flowChartAlternateProcess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498240" y="371160"/>
              <a:ext cx="11062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Arial"/>
                </a:rPr>
                <a:t>1) GL family conten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4" name=""/>
          <p:cNvGrpSpPr/>
          <p:nvPr/>
        </p:nvGrpSpPr>
        <p:grpSpPr>
          <a:xfrm>
            <a:off x="471600" y="5905440"/>
            <a:ext cx="1162080" cy="403200"/>
            <a:chOff x="471600" y="5905440"/>
            <a:chExt cx="1162080" cy="403200"/>
          </a:xfrm>
        </p:grpSpPr>
        <p:sp>
          <p:nvSpPr>
            <p:cNvPr id="45" name=""/>
            <p:cNvSpPr/>
            <p:nvPr/>
          </p:nvSpPr>
          <p:spPr>
            <a:xfrm>
              <a:off x="471600" y="5905440"/>
              <a:ext cx="1162080" cy="403200"/>
            </a:xfrm>
            <a:prstGeom prst="flowChartAlternateProcess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578160" y="5962320"/>
              <a:ext cx="946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BE" sz="1200" spc="-1" strike="noStrike">
                  <a:solidFill>
                    <a:srgbClr val="000000"/>
                  </a:solidFill>
                  <a:latin typeface="Arial"/>
                </a:rPr>
                <a:t>4) SON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7" name=""/>
          <p:cNvSpPr/>
          <p:nvPr/>
        </p:nvSpPr>
        <p:spPr>
          <a:xfrm>
            <a:off x="103320" y="1641600"/>
            <a:ext cx="1896840" cy="576000"/>
          </a:xfrm>
          <a:prstGeom prst="parallelogram">
            <a:avLst>
              <a:gd name="adj" fmla="val 82328"/>
            </a:avLst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372960" y="1714680"/>
            <a:ext cx="14115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) Neighborhood identifica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03320" y="3429000"/>
            <a:ext cx="1896840" cy="576360"/>
          </a:xfrm>
          <a:prstGeom prst="parallelogram">
            <a:avLst>
              <a:gd name="adj" fmla="val 82277"/>
            </a:avLst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344520" y="3489480"/>
            <a:ext cx="15127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) Clustering by transitivit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1" name=""/>
          <p:cNvCxnSpPr>
            <a:stCxn id="42" idx="2"/>
            <a:endCxn id="47" idx="1"/>
          </p:cNvCxnSpPr>
          <p:nvPr/>
        </p:nvCxnSpPr>
        <p:spPr>
          <a:xfrm>
            <a:off x="1051560" y="880920"/>
            <a:ext cx="720" cy="76104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2" name=""/>
          <p:cNvCxnSpPr>
            <a:stCxn id="47" idx="4"/>
            <a:endCxn id="49" idx="1"/>
          </p:cNvCxnSpPr>
          <p:nvPr/>
        </p:nvCxnSpPr>
        <p:spPr>
          <a:xfrm>
            <a:off x="1051920" y="2217600"/>
            <a:ext cx="360" cy="12117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3" name=""/>
          <p:cNvCxnSpPr>
            <a:stCxn id="49" idx="4"/>
            <a:endCxn id="45" idx="0"/>
          </p:cNvCxnSpPr>
          <p:nvPr/>
        </p:nvCxnSpPr>
        <p:spPr>
          <a:xfrm>
            <a:off x="1051920" y="4005360"/>
            <a:ext cx="1080" cy="190044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54" name=""/>
          <p:cNvSpPr/>
          <p:nvPr/>
        </p:nvSpPr>
        <p:spPr>
          <a:xfrm>
            <a:off x="2073240" y="5932440"/>
            <a:ext cx="7832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ee figure 2 SONS d for the complete SONS of YOL075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2046600" y="320760"/>
            <a:ext cx="7846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BE" sz="1400" spc="-1" strike="noStrike">
                <a:solidFill>
                  <a:srgbClr val="ff3300"/>
                </a:solidFill>
                <a:latin typeface="Arial"/>
              </a:rPr>
              <a:t>GL3C0025</a:t>
            </a:r>
            <a:r>
              <a:rPr b="0" lang="fr-BE" sz="1200" spc="-1" strike="noStrike">
                <a:solidFill>
                  <a:srgbClr val="000000"/>
                </a:solidFill>
                <a:latin typeface="Arial"/>
              </a:rPr>
              <a:t>: YOL075c, CAGL0I08019g, ZYRO0B05588g, KLTH0E15796g, SAKL0C08074, KLLA0C04477g, …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6" name=""/>
          <p:cNvGrpSpPr/>
          <p:nvPr/>
        </p:nvGrpSpPr>
        <p:grpSpPr>
          <a:xfrm>
            <a:off x="2073240" y="1641600"/>
            <a:ext cx="7651800" cy="1212840"/>
            <a:chOff x="2073240" y="1641600"/>
            <a:chExt cx="7651800" cy="1212840"/>
          </a:xfrm>
        </p:grpSpPr>
        <p:sp>
          <p:nvSpPr>
            <p:cNvPr id="57" name="Text Box 46"/>
            <p:cNvSpPr/>
            <p:nvPr/>
          </p:nvSpPr>
          <p:spPr>
            <a:xfrm>
              <a:off x="2073240" y="1672920"/>
              <a:ext cx="74448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SAC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Rectangle 38"/>
            <p:cNvSpPr/>
            <p:nvPr/>
          </p:nvSpPr>
          <p:spPr>
            <a:xfrm>
              <a:off x="4632120" y="1641600"/>
              <a:ext cx="557280" cy="3409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L3R176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Rectangle 40"/>
            <p:cNvSpPr/>
            <p:nvPr/>
          </p:nvSpPr>
          <p:spPr>
            <a:xfrm>
              <a:off x="5931000" y="1641600"/>
              <a:ext cx="556920" cy="340920"/>
            </a:xfrm>
            <a:prstGeom prst="rect">
              <a:avLst/>
            </a:prstGeom>
            <a:solidFill>
              <a:srgbClr val="ffffff"/>
            </a:solidFill>
            <a:ln w="2844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YOL075c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Rectangle 43"/>
            <p:cNvSpPr/>
            <p:nvPr/>
          </p:nvSpPr>
          <p:spPr>
            <a:xfrm>
              <a:off x="7872480" y="1641600"/>
              <a:ext cx="556920" cy="3409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L3R176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Rectangle 44"/>
            <p:cNvSpPr/>
            <p:nvPr/>
          </p:nvSpPr>
          <p:spPr>
            <a:xfrm>
              <a:off x="8520120" y="1642680"/>
              <a:ext cx="557280" cy="3380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…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Rectangle 39"/>
            <p:cNvSpPr/>
            <p:nvPr/>
          </p:nvSpPr>
          <p:spPr>
            <a:xfrm>
              <a:off x="6594480" y="1641600"/>
              <a:ext cx="557280" cy="3409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L3R196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Rectangle 38"/>
            <p:cNvSpPr/>
            <p:nvPr/>
          </p:nvSpPr>
          <p:spPr>
            <a:xfrm>
              <a:off x="5280120" y="1641600"/>
              <a:ext cx="556920" cy="3409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L3R176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Rectangle 44"/>
            <p:cNvSpPr/>
            <p:nvPr/>
          </p:nvSpPr>
          <p:spPr>
            <a:xfrm>
              <a:off x="9167760" y="1642680"/>
              <a:ext cx="557280" cy="3380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L3R05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5600520" y="2001600"/>
              <a:ext cx="1224000" cy="824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ff0000"/>
                  </a:solidFill>
                  <a:latin typeface="Arial"/>
                </a:rPr>
                <a:t>Query gene belonging to the GL3C002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ff0000"/>
                  </a:solidFill>
                  <a:latin typeface="Arial"/>
                </a:rPr>
                <a:t>family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Rectangle 44"/>
            <p:cNvSpPr/>
            <p:nvPr/>
          </p:nvSpPr>
          <p:spPr>
            <a:xfrm>
              <a:off x="3354480" y="1641600"/>
              <a:ext cx="556920" cy="3376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…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6681600" y="2001600"/>
              <a:ext cx="358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200" spc="-1" strike="noStrike">
                  <a:solidFill>
                    <a:srgbClr val="000000"/>
                  </a:solidFill>
                  <a:latin typeface="Arial"/>
                </a:rPr>
                <a:t>+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7329240" y="2001600"/>
              <a:ext cx="358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200" spc="-1" strike="noStrike">
                  <a:solidFill>
                    <a:srgbClr val="000000"/>
                  </a:solidFill>
                  <a:latin typeface="Arial"/>
                </a:rPr>
                <a:t>+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7977240" y="2001600"/>
              <a:ext cx="358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200" spc="-1" strike="noStrike">
                  <a:solidFill>
                    <a:srgbClr val="000000"/>
                  </a:solidFill>
                  <a:latin typeface="Arial"/>
                </a:rPr>
                <a:t>+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8553240" y="2001600"/>
              <a:ext cx="503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200" spc="-1" strike="noStrike">
                  <a:solidFill>
                    <a:srgbClr val="000000"/>
                  </a:solidFill>
                  <a:latin typeface="Arial"/>
                </a:rPr>
                <a:t>…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9202680" y="2001600"/>
              <a:ext cx="503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200" spc="-1" strike="noStrike">
                  <a:solidFill>
                    <a:srgbClr val="000000"/>
                  </a:solidFill>
                  <a:latin typeface="Arial"/>
                </a:rPr>
                <a:t>+1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2720880" y="2001600"/>
              <a:ext cx="503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200" spc="-1" strike="noStrike">
                  <a:solidFill>
                    <a:srgbClr val="000000"/>
                  </a:solidFill>
                  <a:latin typeface="Arial"/>
                </a:rPr>
                <a:t>-1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3441600" y="2001600"/>
              <a:ext cx="358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200" spc="-1" strike="noStrike">
                  <a:solidFill>
                    <a:srgbClr val="000000"/>
                  </a:solidFill>
                  <a:latin typeface="Arial"/>
                </a:rPr>
                <a:t>…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4089240" y="2001600"/>
              <a:ext cx="358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200" spc="-1" strike="noStrike">
                  <a:solidFill>
                    <a:srgbClr val="000000"/>
                  </a:solidFill>
                  <a:latin typeface="Arial"/>
                </a:rPr>
                <a:t>-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4665600" y="2001600"/>
              <a:ext cx="503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200" spc="-1" strike="noStrike">
                  <a:solidFill>
                    <a:srgbClr val="000000"/>
                  </a:solidFill>
                  <a:latin typeface="Arial"/>
                </a:rPr>
                <a:t>-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5313240" y="2001600"/>
              <a:ext cx="503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200" spc="-1" strike="noStrike">
                  <a:solidFill>
                    <a:srgbClr val="000000"/>
                  </a:solidFill>
                  <a:latin typeface="Arial"/>
                </a:rPr>
                <a:t>-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 rot="5400000">
              <a:off x="4017960" y="848880"/>
              <a:ext cx="286920" cy="3024000"/>
            </a:xfrm>
            <a:custGeom>
              <a:avLst/>
              <a:gdLst>
                <a:gd name="textAreaLeft" fmla="*/ 0 w 286920"/>
                <a:gd name="textAreaRight" fmla="*/ 103680 w 286920"/>
                <a:gd name="textAreaTop" fmla="*/ 78840 h 3024000"/>
                <a:gd name="textAreaBottom" fmla="*/ 2945160 h 30240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900"/>
                    <a:pt x="10800" y="1800"/>
                  </a:cubicBezTo>
                  <a:lnTo>
                    <a:pt x="10800" y="9000"/>
                  </a:lnTo>
                  <a:cubicBezTo>
                    <a:pt x="10800" y="9900"/>
                    <a:pt x="16200" y="10800"/>
                    <a:pt x="21600" y="10800"/>
                  </a:cubicBezTo>
                  <a:cubicBezTo>
                    <a:pt x="16200" y="10800"/>
                    <a:pt x="10800" y="11700"/>
                    <a:pt x="10800" y="12600"/>
                  </a:cubicBezTo>
                  <a:lnTo>
                    <a:pt x="10800" y="19800"/>
                  </a:lnTo>
                  <a:cubicBezTo>
                    <a:pt x="10800" y="20700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 rot="5400000">
              <a:off x="8049960" y="848520"/>
              <a:ext cx="286920" cy="3024360"/>
            </a:xfrm>
            <a:custGeom>
              <a:avLst/>
              <a:gdLst>
                <a:gd name="textAreaLeft" fmla="*/ 0 w 286920"/>
                <a:gd name="textAreaRight" fmla="*/ 103680 w 286920"/>
                <a:gd name="textAreaTop" fmla="*/ 78840 h 3024360"/>
                <a:gd name="textAreaBottom" fmla="*/ 2945520 h 30243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900"/>
                    <a:pt x="10800" y="1800"/>
                  </a:cubicBezTo>
                  <a:lnTo>
                    <a:pt x="10800" y="9000"/>
                  </a:lnTo>
                  <a:cubicBezTo>
                    <a:pt x="10800" y="9900"/>
                    <a:pt x="16200" y="10800"/>
                    <a:pt x="21600" y="10800"/>
                  </a:cubicBezTo>
                  <a:cubicBezTo>
                    <a:pt x="16200" y="10800"/>
                    <a:pt x="10800" y="11700"/>
                    <a:pt x="10800" y="12600"/>
                  </a:cubicBezTo>
                  <a:lnTo>
                    <a:pt x="10800" y="19800"/>
                  </a:lnTo>
                  <a:cubicBezTo>
                    <a:pt x="10800" y="20700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3727800" y="2577960"/>
              <a:ext cx="877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Neighbor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7749000" y="2577960"/>
              <a:ext cx="877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Neighbor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Rectangle 38"/>
            <p:cNvSpPr/>
            <p:nvPr/>
          </p:nvSpPr>
          <p:spPr>
            <a:xfrm>
              <a:off x="2695320" y="1641600"/>
              <a:ext cx="557280" cy="3409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L3R004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Rectangle 38"/>
            <p:cNvSpPr/>
            <p:nvPr/>
          </p:nvSpPr>
          <p:spPr>
            <a:xfrm>
              <a:off x="4002120" y="1641600"/>
              <a:ext cx="557280" cy="3409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L3C052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Rectangle 38"/>
            <p:cNvSpPr/>
            <p:nvPr/>
          </p:nvSpPr>
          <p:spPr>
            <a:xfrm>
              <a:off x="7243560" y="1641600"/>
              <a:ext cx="557280" cy="3409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L3C252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4" name=""/>
          <p:cNvGrpSpPr/>
          <p:nvPr/>
        </p:nvGrpSpPr>
        <p:grpSpPr>
          <a:xfrm>
            <a:off x="2073240" y="3429000"/>
            <a:ext cx="7653240" cy="2076480"/>
            <a:chOff x="2073240" y="3429000"/>
            <a:chExt cx="7653240" cy="2076480"/>
          </a:xfrm>
        </p:grpSpPr>
        <p:sp>
          <p:nvSpPr>
            <p:cNvPr id="85" name="Text Box 46"/>
            <p:cNvSpPr/>
            <p:nvPr/>
          </p:nvSpPr>
          <p:spPr>
            <a:xfrm>
              <a:off x="2073240" y="3897360"/>
              <a:ext cx="74448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AG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Text Box 46"/>
            <p:cNvSpPr/>
            <p:nvPr/>
          </p:nvSpPr>
          <p:spPr>
            <a:xfrm>
              <a:off x="2073240" y="3462120"/>
              <a:ext cx="74448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SAC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Text Box 34"/>
            <p:cNvSpPr/>
            <p:nvPr/>
          </p:nvSpPr>
          <p:spPr>
            <a:xfrm>
              <a:off x="2073240" y="4330440"/>
              <a:ext cx="74448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KLTH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Rectangle 44"/>
            <p:cNvSpPr/>
            <p:nvPr/>
          </p:nvSpPr>
          <p:spPr>
            <a:xfrm>
              <a:off x="8520120" y="3432240"/>
              <a:ext cx="557280" cy="3380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…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Rectangle 43"/>
            <p:cNvSpPr/>
            <p:nvPr/>
          </p:nvSpPr>
          <p:spPr>
            <a:xfrm>
              <a:off x="8520120" y="3863880"/>
              <a:ext cx="557280" cy="3398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…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Rectangle 44"/>
            <p:cNvSpPr/>
            <p:nvPr/>
          </p:nvSpPr>
          <p:spPr>
            <a:xfrm>
              <a:off x="9167760" y="3863880"/>
              <a:ext cx="557280" cy="3398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L3R176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Rectangle 38"/>
            <p:cNvSpPr/>
            <p:nvPr/>
          </p:nvSpPr>
          <p:spPr>
            <a:xfrm>
              <a:off x="2697120" y="3863880"/>
              <a:ext cx="557280" cy="341280"/>
            </a:xfrm>
            <a:prstGeom prst="rect">
              <a:avLst/>
            </a:prstGeom>
            <a:solidFill>
              <a:srgbClr val="99cc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L3R004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Rectangle 43"/>
            <p:cNvSpPr/>
            <p:nvPr/>
          </p:nvSpPr>
          <p:spPr>
            <a:xfrm>
              <a:off x="8520120" y="4300560"/>
              <a:ext cx="557280" cy="3394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…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3" name=""/>
            <p:cNvGrpSpPr/>
            <p:nvPr/>
          </p:nvGrpSpPr>
          <p:grpSpPr>
            <a:xfrm>
              <a:off x="3354480" y="3430440"/>
              <a:ext cx="556920" cy="1208160"/>
              <a:chOff x="3354480" y="3430440"/>
              <a:chExt cx="556920" cy="1208160"/>
            </a:xfrm>
          </p:grpSpPr>
          <p:sp>
            <p:nvSpPr>
              <p:cNvPr id="94" name="Rectangle 44"/>
              <p:cNvSpPr/>
              <p:nvPr/>
            </p:nvSpPr>
            <p:spPr>
              <a:xfrm>
                <a:off x="3354480" y="3430440"/>
                <a:ext cx="556920" cy="3380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…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Rectangle 43"/>
              <p:cNvSpPr/>
              <p:nvPr/>
            </p:nvSpPr>
            <p:spPr>
              <a:xfrm>
                <a:off x="3354480" y="3863880"/>
                <a:ext cx="556920" cy="33948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…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Rectangle 43"/>
              <p:cNvSpPr/>
              <p:nvPr/>
            </p:nvSpPr>
            <p:spPr>
              <a:xfrm>
                <a:off x="3354480" y="4298760"/>
                <a:ext cx="556920" cy="3398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…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7" name=""/>
            <p:cNvSpPr/>
            <p:nvPr/>
          </p:nvSpPr>
          <p:spPr>
            <a:xfrm>
              <a:off x="5600520" y="4653000"/>
              <a:ext cx="1224000" cy="824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ff0000"/>
                  </a:solidFill>
                  <a:latin typeface="Arial"/>
                </a:rPr>
                <a:t>Queries  belonging to the GL3C002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ff0000"/>
                  </a:solidFill>
                  <a:latin typeface="Arial"/>
                </a:rPr>
                <a:t>family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6681600" y="4653000"/>
              <a:ext cx="358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200" spc="-1" strike="noStrike">
                  <a:solidFill>
                    <a:srgbClr val="000000"/>
                  </a:solidFill>
                  <a:latin typeface="Arial"/>
                </a:rPr>
                <a:t>+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7329240" y="4653000"/>
              <a:ext cx="358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200" spc="-1" strike="noStrike">
                  <a:solidFill>
                    <a:srgbClr val="000000"/>
                  </a:solidFill>
                  <a:latin typeface="Arial"/>
                </a:rPr>
                <a:t>+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7977240" y="4653000"/>
              <a:ext cx="358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200" spc="-1" strike="noStrike">
                  <a:solidFill>
                    <a:srgbClr val="000000"/>
                  </a:solidFill>
                  <a:latin typeface="Arial"/>
                </a:rPr>
                <a:t>+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8553240" y="4653000"/>
              <a:ext cx="503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200" spc="-1" strike="noStrike">
                  <a:solidFill>
                    <a:srgbClr val="000000"/>
                  </a:solidFill>
                  <a:latin typeface="Arial"/>
                </a:rPr>
                <a:t>…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9202680" y="4653000"/>
              <a:ext cx="503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200" spc="-1" strike="noStrike">
                  <a:solidFill>
                    <a:srgbClr val="000000"/>
                  </a:solidFill>
                  <a:latin typeface="Arial"/>
                </a:rPr>
                <a:t>+1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2720880" y="4653000"/>
              <a:ext cx="503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200" spc="-1" strike="noStrike">
                  <a:solidFill>
                    <a:srgbClr val="000000"/>
                  </a:solidFill>
                  <a:latin typeface="Arial"/>
                </a:rPr>
                <a:t>-1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3441600" y="4653000"/>
              <a:ext cx="358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200" spc="-1" strike="noStrike">
                  <a:solidFill>
                    <a:srgbClr val="000000"/>
                  </a:solidFill>
                  <a:latin typeface="Arial"/>
                </a:rPr>
                <a:t>…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4089240" y="4653000"/>
              <a:ext cx="358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200" spc="-1" strike="noStrike">
                  <a:solidFill>
                    <a:srgbClr val="000000"/>
                  </a:solidFill>
                  <a:latin typeface="Arial"/>
                </a:rPr>
                <a:t>-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4665600" y="4653000"/>
              <a:ext cx="503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200" spc="-1" strike="noStrike">
                  <a:solidFill>
                    <a:srgbClr val="000000"/>
                  </a:solidFill>
                  <a:latin typeface="Arial"/>
                </a:rPr>
                <a:t>-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5313240" y="4653000"/>
              <a:ext cx="503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200" spc="-1" strike="noStrike">
                  <a:solidFill>
                    <a:srgbClr val="000000"/>
                  </a:solidFill>
                  <a:latin typeface="Arial"/>
                </a:rPr>
                <a:t>-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 rot="5400000">
              <a:off x="4017960" y="3500280"/>
              <a:ext cx="287280" cy="3024000"/>
            </a:xfrm>
            <a:custGeom>
              <a:avLst/>
              <a:gdLst>
                <a:gd name="textAreaLeft" fmla="*/ 0 w 287280"/>
                <a:gd name="textAreaRight" fmla="*/ 103680 w 287280"/>
                <a:gd name="textAreaTop" fmla="*/ 78840 h 3024000"/>
                <a:gd name="textAreaBottom" fmla="*/ 2945160 h 30240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900"/>
                    <a:pt x="10800" y="1800"/>
                  </a:cubicBezTo>
                  <a:lnTo>
                    <a:pt x="10800" y="9000"/>
                  </a:lnTo>
                  <a:cubicBezTo>
                    <a:pt x="10800" y="9900"/>
                    <a:pt x="16200" y="10800"/>
                    <a:pt x="21600" y="10800"/>
                  </a:cubicBezTo>
                  <a:cubicBezTo>
                    <a:pt x="16200" y="10800"/>
                    <a:pt x="10800" y="11700"/>
                    <a:pt x="10800" y="12600"/>
                  </a:cubicBezTo>
                  <a:lnTo>
                    <a:pt x="10800" y="19800"/>
                  </a:lnTo>
                  <a:cubicBezTo>
                    <a:pt x="10800" y="20700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 rot="5400000">
              <a:off x="8049600" y="3499920"/>
              <a:ext cx="287280" cy="3024360"/>
            </a:xfrm>
            <a:custGeom>
              <a:avLst/>
              <a:gdLst>
                <a:gd name="textAreaLeft" fmla="*/ 0 w 287280"/>
                <a:gd name="textAreaRight" fmla="*/ 103680 w 287280"/>
                <a:gd name="textAreaTop" fmla="*/ 78840 h 3024360"/>
                <a:gd name="textAreaBottom" fmla="*/ 2945520 h 30243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900"/>
                    <a:pt x="10800" y="1800"/>
                  </a:cubicBezTo>
                  <a:lnTo>
                    <a:pt x="10800" y="9000"/>
                  </a:lnTo>
                  <a:cubicBezTo>
                    <a:pt x="10800" y="9900"/>
                    <a:pt x="16200" y="10800"/>
                    <a:pt x="21600" y="10800"/>
                  </a:cubicBezTo>
                  <a:cubicBezTo>
                    <a:pt x="16200" y="10800"/>
                    <a:pt x="10800" y="11700"/>
                    <a:pt x="10800" y="12600"/>
                  </a:cubicBezTo>
                  <a:lnTo>
                    <a:pt x="10800" y="19800"/>
                  </a:lnTo>
                  <a:cubicBezTo>
                    <a:pt x="10800" y="20700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3727800" y="5229000"/>
              <a:ext cx="877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Neighbor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7749000" y="5229000"/>
              <a:ext cx="877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Neighbor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Rectangle 44"/>
            <p:cNvSpPr/>
            <p:nvPr/>
          </p:nvSpPr>
          <p:spPr>
            <a:xfrm>
              <a:off x="9169200" y="3430440"/>
              <a:ext cx="557280" cy="3380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L3R05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Rectangle 38"/>
            <p:cNvSpPr/>
            <p:nvPr/>
          </p:nvSpPr>
          <p:spPr>
            <a:xfrm>
              <a:off x="2697120" y="3429000"/>
              <a:ext cx="557280" cy="341280"/>
            </a:xfrm>
            <a:prstGeom prst="rect">
              <a:avLst/>
            </a:prstGeom>
            <a:solidFill>
              <a:srgbClr val="99cc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L3R004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Rectangle 44"/>
            <p:cNvSpPr/>
            <p:nvPr/>
          </p:nvSpPr>
          <p:spPr>
            <a:xfrm>
              <a:off x="9167760" y="4302000"/>
              <a:ext cx="557280" cy="3380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L3R214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Rectangle 38"/>
            <p:cNvSpPr/>
            <p:nvPr/>
          </p:nvSpPr>
          <p:spPr>
            <a:xfrm>
              <a:off x="2695320" y="4298760"/>
              <a:ext cx="557280" cy="3412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L3C271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Rectangle 38"/>
            <p:cNvSpPr/>
            <p:nvPr/>
          </p:nvSpPr>
          <p:spPr>
            <a:xfrm>
              <a:off x="4653000" y="3430440"/>
              <a:ext cx="556920" cy="341280"/>
            </a:xfrm>
            <a:prstGeom prst="rect">
              <a:avLst/>
            </a:prstGeom>
            <a:solidFill>
              <a:srgbClr val="abfbab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L3R176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Rectangle 40"/>
            <p:cNvSpPr/>
            <p:nvPr/>
          </p:nvSpPr>
          <p:spPr>
            <a:xfrm>
              <a:off x="5943600" y="3430440"/>
              <a:ext cx="557280" cy="341280"/>
            </a:xfrm>
            <a:prstGeom prst="rect">
              <a:avLst/>
            </a:prstGeom>
            <a:solidFill>
              <a:srgbClr val="ffffff"/>
            </a:solidFill>
            <a:ln w="2844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YOL075c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Rectangle 41"/>
            <p:cNvSpPr/>
            <p:nvPr/>
          </p:nvSpPr>
          <p:spPr>
            <a:xfrm>
              <a:off x="7243560" y="3430440"/>
              <a:ext cx="557280" cy="341280"/>
            </a:xfrm>
            <a:prstGeom prst="rect">
              <a:avLst/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L3C252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Rectangle 43"/>
            <p:cNvSpPr/>
            <p:nvPr/>
          </p:nvSpPr>
          <p:spPr>
            <a:xfrm>
              <a:off x="7893000" y="3430440"/>
              <a:ext cx="557280" cy="341280"/>
            </a:xfrm>
            <a:prstGeom prst="rect">
              <a:avLst/>
            </a:prstGeom>
            <a:solidFill>
              <a:srgbClr val="d9d9d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L3R176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Rectangle 45"/>
            <p:cNvSpPr/>
            <p:nvPr/>
          </p:nvSpPr>
          <p:spPr>
            <a:xfrm>
              <a:off x="4002120" y="3430440"/>
              <a:ext cx="557280" cy="341280"/>
            </a:xfrm>
            <a:prstGeom prst="rect">
              <a:avLst/>
            </a:prstGeom>
            <a:solidFill>
              <a:srgbClr val="9c9cd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L3C052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Rectangle 39"/>
            <p:cNvSpPr/>
            <p:nvPr/>
          </p:nvSpPr>
          <p:spPr>
            <a:xfrm>
              <a:off x="6595920" y="3430440"/>
              <a:ext cx="557280" cy="341280"/>
            </a:xfrm>
            <a:prstGeom prst="rect">
              <a:avLst/>
            </a:prstGeom>
            <a:solidFill>
              <a:srgbClr val="ff8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L3R196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Rectangle 38"/>
            <p:cNvSpPr/>
            <p:nvPr/>
          </p:nvSpPr>
          <p:spPr>
            <a:xfrm>
              <a:off x="5300640" y="3430440"/>
              <a:ext cx="557280" cy="341280"/>
            </a:xfrm>
            <a:prstGeom prst="rect">
              <a:avLst/>
            </a:prstGeom>
            <a:solidFill>
              <a:srgbClr val="99cc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L3R176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Rectangle 38"/>
            <p:cNvSpPr/>
            <p:nvPr/>
          </p:nvSpPr>
          <p:spPr>
            <a:xfrm>
              <a:off x="4653000" y="3862440"/>
              <a:ext cx="556920" cy="341280"/>
            </a:xfrm>
            <a:prstGeom prst="rect">
              <a:avLst/>
            </a:prstGeom>
            <a:solidFill>
              <a:srgbClr val="abfbab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L3R176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Rectangle 40"/>
            <p:cNvSpPr/>
            <p:nvPr/>
          </p:nvSpPr>
          <p:spPr>
            <a:xfrm>
              <a:off x="5943600" y="3862440"/>
              <a:ext cx="557280" cy="341280"/>
            </a:xfrm>
            <a:prstGeom prst="rect">
              <a:avLst/>
            </a:prstGeom>
            <a:solidFill>
              <a:srgbClr val="ffffff"/>
            </a:solidFill>
            <a:ln w="2844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I</a:t>
              </a: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 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801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Rectangle 41"/>
            <p:cNvSpPr/>
            <p:nvPr/>
          </p:nvSpPr>
          <p:spPr>
            <a:xfrm>
              <a:off x="7243560" y="3862440"/>
              <a:ext cx="557280" cy="341280"/>
            </a:xfrm>
            <a:prstGeom prst="rect">
              <a:avLst/>
            </a:prstGeom>
            <a:solidFill>
              <a:srgbClr val="ffcc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L3C252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Rectangle 43"/>
            <p:cNvSpPr/>
            <p:nvPr/>
          </p:nvSpPr>
          <p:spPr>
            <a:xfrm>
              <a:off x="7893000" y="3862440"/>
              <a:ext cx="557280" cy="341280"/>
            </a:xfrm>
            <a:prstGeom prst="rect">
              <a:avLst/>
            </a:prstGeom>
            <a:solidFill>
              <a:srgbClr val="d9d9d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L3R176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Rectangle 45"/>
            <p:cNvSpPr/>
            <p:nvPr/>
          </p:nvSpPr>
          <p:spPr>
            <a:xfrm>
              <a:off x="4002120" y="3862440"/>
              <a:ext cx="557280" cy="341280"/>
            </a:xfrm>
            <a:prstGeom prst="rect">
              <a:avLst/>
            </a:prstGeom>
            <a:solidFill>
              <a:srgbClr val="9c9cd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L3C052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Rectangle 38"/>
            <p:cNvSpPr/>
            <p:nvPr/>
          </p:nvSpPr>
          <p:spPr>
            <a:xfrm>
              <a:off x="5300640" y="3862440"/>
              <a:ext cx="557280" cy="341280"/>
            </a:xfrm>
            <a:prstGeom prst="rect">
              <a:avLst/>
            </a:prstGeom>
            <a:solidFill>
              <a:srgbClr val="99cc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L3R176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Rectangle 40"/>
            <p:cNvSpPr/>
            <p:nvPr/>
          </p:nvSpPr>
          <p:spPr>
            <a:xfrm>
              <a:off x="5941800" y="4298760"/>
              <a:ext cx="557280" cy="341280"/>
            </a:xfrm>
            <a:prstGeom prst="rect">
              <a:avLst/>
            </a:prstGeom>
            <a:solidFill>
              <a:srgbClr val="ffffff"/>
            </a:solidFill>
            <a:ln w="2844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E</a:t>
              </a: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 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579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Rectangle 39"/>
            <p:cNvSpPr/>
            <p:nvPr/>
          </p:nvSpPr>
          <p:spPr>
            <a:xfrm>
              <a:off x="6594480" y="4298760"/>
              <a:ext cx="557280" cy="3412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L3R196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Rectangle 38"/>
            <p:cNvSpPr/>
            <p:nvPr/>
          </p:nvSpPr>
          <p:spPr>
            <a:xfrm>
              <a:off x="4002120" y="4298760"/>
              <a:ext cx="557280" cy="3412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L3R400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Rectangle 39"/>
            <p:cNvSpPr/>
            <p:nvPr/>
          </p:nvSpPr>
          <p:spPr>
            <a:xfrm>
              <a:off x="5298840" y="4298760"/>
              <a:ext cx="557280" cy="3412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L3R305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Rectangle 39"/>
            <p:cNvSpPr/>
            <p:nvPr/>
          </p:nvSpPr>
          <p:spPr>
            <a:xfrm>
              <a:off x="4649760" y="4298760"/>
              <a:ext cx="557280" cy="3412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L3C070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Rectangle 39"/>
            <p:cNvSpPr/>
            <p:nvPr/>
          </p:nvSpPr>
          <p:spPr>
            <a:xfrm>
              <a:off x="7243560" y="4298760"/>
              <a:ext cx="557280" cy="341280"/>
            </a:xfrm>
            <a:prstGeom prst="rect">
              <a:avLst/>
            </a:prstGeom>
            <a:solidFill>
              <a:srgbClr val="ff8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L3R196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Rectangle 44"/>
            <p:cNvSpPr/>
            <p:nvPr/>
          </p:nvSpPr>
          <p:spPr>
            <a:xfrm>
              <a:off x="7891560" y="4298760"/>
              <a:ext cx="556920" cy="3398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L3C196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Rectangle 39"/>
            <p:cNvSpPr/>
            <p:nvPr/>
          </p:nvSpPr>
          <p:spPr>
            <a:xfrm>
              <a:off x="6595920" y="3862440"/>
              <a:ext cx="557280" cy="3412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L3C25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37" name=""/>
            <p:cNvCxnSpPr>
              <a:stCxn id="113" idx="2"/>
              <a:endCxn id="91" idx="0"/>
            </p:cNvCxnSpPr>
            <p:nvPr/>
          </p:nvCxnSpPr>
          <p:spPr>
            <a:xfrm>
              <a:off x="2975760" y="3770280"/>
              <a:ext cx="360" cy="9396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cxnSp>
          <p:nvCxnSpPr>
            <p:cNvPr id="138" name=""/>
            <p:cNvCxnSpPr>
              <a:stCxn id="120" idx="2"/>
              <a:endCxn id="127" idx="0"/>
            </p:cNvCxnSpPr>
            <p:nvPr/>
          </p:nvCxnSpPr>
          <p:spPr>
            <a:xfrm>
              <a:off x="4280760" y="3771720"/>
              <a:ext cx="360" cy="9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cxnSp>
          <p:nvCxnSpPr>
            <p:cNvPr id="139" name=""/>
            <p:cNvCxnSpPr>
              <a:stCxn id="116" idx="2"/>
              <a:endCxn id="123" idx="0"/>
            </p:cNvCxnSpPr>
            <p:nvPr/>
          </p:nvCxnSpPr>
          <p:spPr>
            <a:xfrm>
              <a:off x="4931280" y="3771720"/>
              <a:ext cx="360" cy="9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cxnSp>
          <p:nvCxnSpPr>
            <p:cNvPr id="140" name=""/>
            <p:cNvCxnSpPr>
              <a:stCxn id="122" idx="2"/>
              <a:endCxn id="128" idx="0"/>
            </p:cNvCxnSpPr>
            <p:nvPr/>
          </p:nvCxnSpPr>
          <p:spPr>
            <a:xfrm>
              <a:off x="5579280" y="3771720"/>
              <a:ext cx="360" cy="9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cxnSp>
          <p:nvCxnSpPr>
            <p:cNvPr id="141" name=""/>
            <p:cNvCxnSpPr>
              <a:stCxn id="118" idx="2"/>
              <a:endCxn id="125" idx="0"/>
            </p:cNvCxnSpPr>
            <p:nvPr/>
          </p:nvCxnSpPr>
          <p:spPr>
            <a:xfrm>
              <a:off x="7522200" y="3771720"/>
              <a:ext cx="360" cy="9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cxnSp>
          <p:nvCxnSpPr>
            <p:cNvPr id="142" name=""/>
            <p:cNvCxnSpPr>
              <a:stCxn id="119" idx="2"/>
              <a:endCxn id="126" idx="0"/>
            </p:cNvCxnSpPr>
            <p:nvPr/>
          </p:nvCxnSpPr>
          <p:spPr>
            <a:xfrm>
              <a:off x="8171640" y="3771720"/>
              <a:ext cx="360" cy="9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cxnSp>
          <p:nvCxnSpPr>
            <p:cNvPr id="143" name=""/>
            <p:cNvCxnSpPr>
              <a:stCxn id="121" idx="3"/>
              <a:endCxn id="134" idx="1"/>
            </p:cNvCxnSpPr>
            <p:nvPr/>
          </p:nvCxnSpPr>
          <p:spPr>
            <a:xfrm>
              <a:off x="7153200" y="3601080"/>
              <a:ext cx="90720" cy="868680"/>
            </a:xfrm>
            <a:prstGeom prst="bentConnector5">
              <a:avLst>
                <a:gd name="adj1" fmla="val 256175"/>
                <a:gd name="adj2" fmla="val 50000"/>
                <a:gd name="adj3" fmla="val -156175"/>
              </a:avLst>
            </a:prstGeom>
            <a:ln w="9360">
              <a:solidFill>
                <a:srgbClr val="000000"/>
              </a:solidFill>
              <a:miter/>
            </a:ln>
          </p:spPr>
        </p:cxn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2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3-06T14:26:11Z</dcterms:created>
  <dc:creator> </dc:creator>
  <dc:description/>
  <dc:language>en-US</dc:language>
  <cp:lastModifiedBy>Marie-Line</cp:lastModifiedBy>
  <dcterms:modified xsi:type="dcterms:W3CDTF">2009-07-17T11:43:27Z</dcterms:modified>
  <cp:revision>37</cp:revision>
  <dc:subject/>
  <dc:title>Diapositive 1</dc:title>
</cp:coreProperties>
</file>